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7279938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95" d="100"/>
          <a:sy n="95" d="100"/>
        </p:scale>
        <p:origin x="248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59992" y="1122363"/>
            <a:ext cx="12959954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59992" y="3602038"/>
            <a:ext cx="12959954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56326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15772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365955" y="365125"/>
            <a:ext cx="3725987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87996" y="365125"/>
            <a:ext cx="10961961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2180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2955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8996" y="1709739"/>
            <a:ext cx="14903947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78996" y="4589464"/>
            <a:ext cx="14903947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2595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87996" y="1825625"/>
            <a:ext cx="7343974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747968" y="1825625"/>
            <a:ext cx="7343974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507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6" y="365126"/>
            <a:ext cx="14903947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90247" y="1681163"/>
            <a:ext cx="731022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90247" y="2505075"/>
            <a:ext cx="7310223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747969" y="1681163"/>
            <a:ext cx="734622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747969" y="2505075"/>
            <a:ext cx="7346224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0103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465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552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7" y="457200"/>
            <a:ext cx="557322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346224" y="987426"/>
            <a:ext cx="8747969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7" y="2057400"/>
            <a:ext cx="557322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1248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0247" y="457200"/>
            <a:ext cx="557322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346224" y="987426"/>
            <a:ext cx="8747969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0247" y="2057400"/>
            <a:ext cx="557322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4562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87996" y="365126"/>
            <a:ext cx="1490394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87996" y="1825625"/>
            <a:ext cx="1490394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87996" y="6356351"/>
            <a:ext cx="388798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BAF5A-364C-482C-9651-5CE357715960}" type="datetimeFigureOut">
              <a:rPr lang="zh-CN" altLang="en-US" smtClean="0"/>
              <a:t>2020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723980" y="6356351"/>
            <a:ext cx="583197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203956" y="6356351"/>
            <a:ext cx="3887986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334CE-DCD8-4BAB-954B-953147F926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0902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D3259B4C-8F41-4F54-92A9-2CDE9D36A07A}"/>
              </a:ext>
            </a:extLst>
          </p:cNvPr>
          <p:cNvGrpSpPr/>
          <p:nvPr/>
        </p:nvGrpSpPr>
        <p:grpSpPr>
          <a:xfrm>
            <a:off x="247437" y="364154"/>
            <a:ext cx="16607717" cy="5751265"/>
            <a:chOff x="-1502407" y="370135"/>
            <a:chExt cx="16607717" cy="5751265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09D36155-DDC8-4207-AD4B-C77840D60586}"/>
                </a:ext>
              </a:extLst>
            </p:cNvPr>
            <p:cNvGrpSpPr/>
            <p:nvPr/>
          </p:nvGrpSpPr>
          <p:grpSpPr>
            <a:xfrm>
              <a:off x="-1502407" y="665981"/>
              <a:ext cx="5388669" cy="5455418"/>
              <a:chOff x="3274039" y="553208"/>
              <a:chExt cx="5123954" cy="5136508"/>
            </a:xfrm>
          </p:grpSpPr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CD1808AE-462E-4DDE-829E-A48EA5F328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794006" y="1168284"/>
                <a:ext cx="4603987" cy="4521432"/>
              </a:xfrm>
              <a:prstGeom prst="rect">
                <a:avLst/>
              </a:prstGeom>
            </p:spPr>
          </p:pic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28BD7463-1D2F-4F86-99D4-0B3986190AF4}"/>
                  </a:ext>
                </a:extLst>
              </p:cNvPr>
              <p:cNvSpPr/>
              <p:nvPr/>
            </p:nvSpPr>
            <p:spPr>
              <a:xfrm>
                <a:off x="4512790" y="553208"/>
                <a:ext cx="2968032" cy="34774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baicalensis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77713B88-77D2-4E94-A833-3B3C508C34A9}"/>
                  </a:ext>
                </a:extLst>
              </p:cNvPr>
              <p:cNvSpPr/>
              <p:nvPr/>
            </p:nvSpPr>
            <p:spPr>
              <a:xfrm rot="16200000">
                <a:off x="2119039" y="3006155"/>
                <a:ext cx="2661190" cy="35118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rbata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F772F750-68D9-4C0C-8509-B8077686B59B}"/>
                </a:ext>
              </a:extLst>
            </p:cNvPr>
            <p:cNvGrpSpPr/>
            <p:nvPr/>
          </p:nvGrpSpPr>
          <p:grpSpPr>
            <a:xfrm>
              <a:off x="4086434" y="665981"/>
              <a:ext cx="4364374" cy="4278608"/>
              <a:chOff x="3270161" y="537950"/>
              <a:chExt cx="4364374" cy="4278608"/>
            </a:xfrm>
          </p:grpSpPr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67F029C1-62FA-42B4-AF30-4F567CFB1F39}"/>
                  </a:ext>
                </a:extLst>
              </p:cNvPr>
              <p:cNvSpPr/>
              <p:nvPr/>
            </p:nvSpPr>
            <p:spPr>
              <a:xfrm>
                <a:off x="4513168" y="537950"/>
                <a:ext cx="3121367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baicalensis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0B95E0D5-C4C3-4A06-BCBC-91C4AE9A79AE}"/>
                  </a:ext>
                </a:extLst>
              </p:cNvPr>
              <p:cNvSpPr/>
              <p:nvPr/>
            </p:nvSpPr>
            <p:spPr>
              <a:xfrm rot="16200000">
                <a:off x="2067267" y="3244333"/>
                <a:ext cx="2775119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. </a:t>
                </a:r>
                <a:r>
                  <a:rPr lang="en-US" altLang="zh-CN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dicum</a:t>
                </a:r>
                <a:r>
                  <a:rPr lang="en-US" altLang="zh-CN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dirty="0">
                    <a:latin typeface="Arial" panose="020B0604020202020204" pitchFamily="34" charset="0"/>
                    <a:cs typeface="Arial" panose="020B0604020202020204" pitchFamily="34" charset="0"/>
                  </a:rPr>
                  <a:t>chromosomes</a:t>
                </a:r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883D755C-4777-4E0F-B949-FE3AAF033E17}"/>
                </a:ext>
              </a:extLst>
            </p:cNvPr>
            <p:cNvSpPr/>
            <p:nvPr/>
          </p:nvSpPr>
          <p:spPr>
            <a:xfrm>
              <a:off x="11217614" y="665981"/>
              <a:ext cx="276229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en-US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barbata</a:t>
              </a:r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zh-CN" altLang="en-US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EC265589-EE0D-4B83-AAE8-1C37784B619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34388" y="1309015"/>
              <a:ext cx="4892926" cy="4812384"/>
            </a:xfrm>
            <a:prstGeom prst="rect">
              <a:avLst/>
            </a:prstGeom>
          </p:spPr>
        </p:pic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27425E46-0D6A-42EF-A4FA-60C3B0F84FA2}"/>
                </a:ext>
              </a:extLst>
            </p:cNvPr>
            <p:cNvSpPr/>
            <p:nvPr/>
          </p:nvSpPr>
          <p:spPr>
            <a:xfrm rot="16200000">
              <a:off x="8578221" y="3352038"/>
              <a:ext cx="2775119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S. </a:t>
              </a:r>
              <a:r>
                <a:rPr lang="en-US" altLang="zh-CN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ndicum</a:t>
              </a:r>
              <a:r>
                <a:rPr lang="en-US" altLang="zh-CN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chromosomes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49A86AA7-7BF3-4275-9B41-24894FF686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229070" y="1319246"/>
              <a:ext cx="4876240" cy="4802154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F7DA831-4690-40D7-AE5E-5C866F16CC16}"/>
                </a:ext>
              </a:extLst>
            </p:cNvPr>
            <p:cNvSpPr txBox="1"/>
            <p:nvPr/>
          </p:nvSpPr>
          <p:spPr>
            <a:xfrm>
              <a:off x="-995028" y="379231"/>
              <a:ext cx="3325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514D63E-5EBC-4F6B-98C8-D983650BC2DF}"/>
                </a:ext>
              </a:extLst>
            </p:cNvPr>
            <p:cNvSpPr txBox="1"/>
            <p:nvPr/>
          </p:nvSpPr>
          <p:spPr>
            <a:xfrm>
              <a:off x="4455766" y="374683"/>
              <a:ext cx="3325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BFB7B8DA-9849-4DF3-9B7F-94AC8CEB1223}"/>
                </a:ext>
              </a:extLst>
            </p:cNvPr>
            <p:cNvSpPr txBox="1"/>
            <p:nvPr/>
          </p:nvSpPr>
          <p:spPr>
            <a:xfrm>
              <a:off x="10150447" y="370135"/>
              <a:ext cx="33253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" name="图片 2">
            <a:extLst>
              <a:ext uri="{FF2B5EF4-FFF2-40B4-BE49-F238E27FC236}">
                <a16:creationId xmlns:a16="http://schemas.microsoft.com/office/drawing/2014/main" id="{4B8B6BA6-4AF0-3349-9205-29E9AAE0CE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7475" y="1073170"/>
            <a:ext cx="15668195" cy="431800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BEA23D8-676F-3148-9855-E73EDB4B160F}"/>
              </a:ext>
            </a:extLst>
          </p:cNvPr>
          <p:cNvSpPr txBox="1"/>
          <p:nvPr/>
        </p:nvSpPr>
        <p:spPr>
          <a:xfrm>
            <a:off x="921085" y="1221420"/>
            <a:ext cx="2614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1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2       Sbai3   Sbai4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7F8ABC3-177F-0E49-9E62-C6ABC0D4EC61}"/>
              </a:ext>
            </a:extLst>
          </p:cNvPr>
          <p:cNvSpPr txBox="1"/>
          <p:nvPr/>
        </p:nvSpPr>
        <p:spPr>
          <a:xfrm rot="19367996">
            <a:off x="3452079" y="124443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5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DF7E544-1A85-9747-9BFE-65BE4B85AD17}"/>
              </a:ext>
            </a:extLst>
          </p:cNvPr>
          <p:cNvSpPr txBox="1"/>
          <p:nvPr/>
        </p:nvSpPr>
        <p:spPr>
          <a:xfrm rot="19300580">
            <a:off x="3871438" y="121737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6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65BB55C-A530-1349-8EE1-21A38A59878A}"/>
              </a:ext>
            </a:extLst>
          </p:cNvPr>
          <p:cNvSpPr txBox="1"/>
          <p:nvPr/>
        </p:nvSpPr>
        <p:spPr>
          <a:xfrm rot="19300580">
            <a:off x="4225543" y="1221854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7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D26828D-7EDF-EC4A-B30F-982EDE6D94E2}"/>
              </a:ext>
            </a:extLst>
          </p:cNvPr>
          <p:cNvSpPr txBox="1"/>
          <p:nvPr/>
        </p:nvSpPr>
        <p:spPr>
          <a:xfrm rot="19300580">
            <a:off x="4600960" y="124163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8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CEF45CB-46A9-004F-B40B-95843D9F1C3A}"/>
              </a:ext>
            </a:extLst>
          </p:cNvPr>
          <p:cNvSpPr txBox="1"/>
          <p:nvPr/>
        </p:nvSpPr>
        <p:spPr>
          <a:xfrm rot="19300580">
            <a:off x="4982386" y="124053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9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A330ECB-8356-CD44-BC00-88E60F5C5B5E}"/>
              </a:ext>
            </a:extLst>
          </p:cNvPr>
          <p:cNvSpPr txBox="1"/>
          <p:nvPr/>
        </p:nvSpPr>
        <p:spPr>
          <a:xfrm>
            <a:off x="6437862" y="1271809"/>
            <a:ext cx="26148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1</a:t>
            </a:r>
            <a:r>
              <a:rPr kumimoji="1"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</a:t>
            </a:r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2       Sbai3   Sbai4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4CAAA73-2BCB-EC46-8822-3CA0D66D87F7}"/>
              </a:ext>
            </a:extLst>
          </p:cNvPr>
          <p:cNvSpPr txBox="1"/>
          <p:nvPr/>
        </p:nvSpPr>
        <p:spPr>
          <a:xfrm rot="19367996">
            <a:off x="8968856" y="129482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5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80B54FB-D3AF-164C-9227-5CAA225C11E8}"/>
              </a:ext>
            </a:extLst>
          </p:cNvPr>
          <p:cNvSpPr txBox="1"/>
          <p:nvPr/>
        </p:nvSpPr>
        <p:spPr>
          <a:xfrm rot="19300580">
            <a:off x="9388215" y="126776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6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E9FBA9C-4396-394C-A8C1-9471FF3D1540}"/>
              </a:ext>
            </a:extLst>
          </p:cNvPr>
          <p:cNvSpPr txBox="1"/>
          <p:nvPr/>
        </p:nvSpPr>
        <p:spPr>
          <a:xfrm rot="19300580">
            <a:off x="9742320" y="127224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7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43F3D215-792F-E849-AB0F-4604B8ADD732}"/>
              </a:ext>
            </a:extLst>
          </p:cNvPr>
          <p:cNvSpPr txBox="1"/>
          <p:nvPr/>
        </p:nvSpPr>
        <p:spPr>
          <a:xfrm rot="19300580">
            <a:off x="10117737" y="1292021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8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735C7CE-D2B6-A747-9B93-0AC42E3B43F1}"/>
              </a:ext>
            </a:extLst>
          </p:cNvPr>
          <p:cNvSpPr txBox="1"/>
          <p:nvPr/>
        </p:nvSpPr>
        <p:spPr>
          <a:xfrm rot="19300580">
            <a:off x="10499163" y="129092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i9</a:t>
            </a:r>
            <a:endParaRPr kumimoji="1"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16329985-9665-8D43-A7DD-0AED2223E61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72596" y="1596814"/>
            <a:ext cx="535204" cy="4518604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FFBD464D-1911-C948-AE41-24A99C52338A}"/>
              </a:ext>
            </a:extLst>
          </p:cNvPr>
          <p:cNvSpPr txBox="1"/>
          <p:nvPr/>
        </p:nvSpPr>
        <p:spPr>
          <a:xfrm>
            <a:off x="5244187" y="1629118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3948937-B1AB-C448-94E7-3D96B79272BF}"/>
              </a:ext>
            </a:extLst>
          </p:cNvPr>
          <p:cNvSpPr txBox="1"/>
          <p:nvPr/>
        </p:nvSpPr>
        <p:spPr>
          <a:xfrm>
            <a:off x="5240549" y="197575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2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DAAC003-4343-694F-BECD-82BECADF69AD}"/>
              </a:ext>
            </a:extLst>
          </p:cNvPr>
          <p:cNvSpPr txBox="1"/>
          <p:nvPr/>
        </p:nvSpPr>
        <p:spPr>
          <a:xfrm>
            <a:off x="5240549" y="234240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3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849E9FF-825C-E14F-B5FB-B350011B491D}"/>
              </a:ext>
            </a:extLst>
          </p:cNvPr>
          <p:cNvSpPr txBox="1"/>
          <p:nvPr/>
        </p:nvSpPr>
        <p:spPr>
          <a:xfrm>
            <a:off x="5240549" y="284418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4</a:t>
            </a: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06E7F57-028D-1846-AF79-57DE8AFB5363}"/>
              </a:ext>
            </a:extLst>
          </p:cNvPr>
          <p:cNvSpPr txBox="1"/>
          <p:nvPr/>
        </p:nvSpPr>
        <p:spPr>
          <a:xfrm>
            <a:off x="5240549" y="3404004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5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EA9D9B4-D4F6-9B4B-AA10-2D15A72182A8}"/>
              </a:ext>
            </a:extLst>
          </p:cNvPr>
          <p:cNvSpPr txBox="1"/>
          <p:nvPr/>
        </p:nvSpPr>
        <p:spPr>
          <a:xfrm>
            <a:off x="5240549" y="3772847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6</a:t>
            </a: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BA4DC86-799C-6348-B3BB-A5EAC3ABBCB5}"/>
              </a:ext>
            </a:extLst>
          </p:cNvPr>
          <p:cNvSpPr txBox="1"/>
          <p:nvPr/>
        </p:nvSpPr>
        <p:spPr>
          <a:xfrm>
            <a:off x="5240549" y="4062523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7</a:t>
            </a: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506B81C-15A4-7746-AEB2-842770DB9274}"/>
              </a:ext>
            </a:extLst>
          </p:cNvPr>
          <p:cNvSpPr txBox="1"/>
          <p:nvPr/>
        </p:nvSpPr>
        <p:spPr>
          <a:xfrm>
            <a:off x="5240549" y="4302617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8</a:t>
            </a: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F2EB76BF-8D23-654B-9068-4DD764D4F3A2}"/>
              </a:ext>
            </a:extLst>
          </p:cNvPr>
          <p:cNvSpPr txBox="1"/>
          <p:nvPr/>
        </p:nvSpPr>
        <p:spPr>
          <a:xfrm>
            <a:off x="5240549" y="470145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9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2021B43D-0A1C-7D44-95BC-D5C31F27E557}"/>
              </a:ext>
            </a:extLst>
          </p:cNvPr>
          <p:cNvSpPr txBox="1"/>
          <p:nvPr/>
        </p:nvSpPr>
        <p:spPr>
          <a:xfrm>
            <a:off x="5240549" y="510259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0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8F58AD9-EBCE-364D-B9A5-20DF43FAA75C}"/>
              </a:ext>
            </a:extLst>
          </p:cNvPr>
          <p:cNvSpPr txBox="1"/>
          <p:nvPr/>
        </p:nvSpPr>
        <p:spPr>
          <a:xfrm>
            <a:off x="5240549" y="5365244"/>
            <a:ext cx="6669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1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CD080A7-E1A6-EE4B-BFB2-2112107F633B}"/>
              </a:ext>
            </a:extLst>
          </p:cNvPr>
          <p:cNvSpPr txBox="1"/>
          <p:nvPr/>
        </p:nvSpPr>
        <p:spPr>
          <a:xfrm>
            <a:off x="5240549" y="5605338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2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B47FCC45-03F5-7A4E-BBF2-32CB9B41AFFE}"/>
              </a:ext>
            </a:extLst>
          </p:cNvPr>
          <p:cNvSpPr txBox="1"/>
          <p:nvPr/>
        </p:nvSpPr>
        <p:spPr>
          <a:xfrm>
            <a:off x="5240549" y="581996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3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0F58424-1DBB-874D-B709-1AF9E12AFE97}"/>
              </a:ext>
            </a:extLst>
          </p:cNvPr>
          <p:cNvSpPr txBox="1"/>
          <p:nvPr/>
        </p:nvSpPr>
        <p:spPr>
          <a:xfrm rot="18898324">
            <a:off x="11911264" y="124299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7172B58-6C16-0C44-9861-BD5E95C44F36}"/>
              </a:ext>
            </a:extLst>
          </p:cNvPr>
          <p:cNvSpPr txBox="1"/>
          <p:nvPr/>
        </p:nvSpPr>
        <p:spPr>
          <a:xfrm rot="18898324">
            <a:off x="12325134" y="122765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2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246224F-887D-EE46-9E92-63220A9DE6AF}"/>
              </a:ext>
            </a:extLst>
          </p:cNvPr>
          <p:cNvSpPr txBox="1"/>
          <p:nvPr/>
        </p:nvSpPr>
        <p:spPr>
          <a:xfrm rot="18898324">
            <a:off x="12740816" y="1234264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3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C695A5B-F7CE-F042-997D-D9FB534BA1C5}"/>
              </a:ext>
            </a:extLst>
          </p:cNvPr>
          <p:cNvSpPr txBox="1"/>
          <p:nvPr/>
        </p:nvSpPr>
        <p:spPr>
          <a:xfrm rot="18898324">
            <a:off x="13173799" y="125014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4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A632D58A-974F-0B46-AFAD-6DDDA9B71783}"/>
              </a:ext>
            </a:extLst>
          </p:cNvPr>
          <p:cNvSpPr txBox="1"/>
          <p:nvPr/>
        </p:nvSpPr>
        <p:spPr>
          <a:xfrm rot="18898324">
            <a:off x="13677986" y="124299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5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FB5D68D5-0B66-874F-82B8-945859C1833B}"/>
              </a:ext>
            </a:extLst>
          </p:cNvPr>
          <p:cNvSpPr txBox="1"/>
          <p:nvPr/>
        </p:nvSpPr>
        <p:spPr>
          <a:xfrm rot="18898324">
            <a:off x="14110743" y="1234264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6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C8CF46A6-78B8-BE4B-9BF5-A4367B16893E}"/>
              </a:ext>
            </a:extLst>
          </p:cNvPr>
          <p:cNvSpPr txBox="1"/>
          <p:nvPr/>
        </p:nvSpPr>
        <p:spPr>
          <a:xfrm rot="18898324">
            <a:off x="14411281" y="1242469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7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A0C6EA2-4764-7147-9D7C-47BBBC8568BD}"/>
              </a:ext>
            </a:extLst>
          </p:cNvPr>
          <p:cNvSpPr txBox="1"/>
          <p:nvPr/>
        </p:nvSpPr>
        <p:spPr>
          <a:xfrm rot="18898324">
            <a:off x="14688315" y="1253867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8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8ED10DC0-01F3-DD4E-8F88-E105F36C626A}"/>
              </a:ext>
            </a:extLst>
          </p:cNvPr>
          <p:cNvSpPr txBox="1"/>
          <p:nvPr/>
        </p:nvSpPr>
        <p:spPr>
          <a:xfrm rot="18898324">
            <a:off x="15014907" y="1236615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9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91DA6BA-6C38-5E4D-820C-5672ADED90C7}"/>
              </a:ext>
            </a:extLst>
          </p:cNvPr>
          <p:cNvSpPr txBox="1"/>
          <p:nvPr/>
        </p:nvSpPr>
        <p:spPr>
          <a:xfrm rot="18898324">
            <a:off x="15417567" y="1221399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0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D5E61B97-076C-0E41-8E36-70101FD7136E}"/>
              </a:ext>
            </a:extLst>
          </p:cNvPr>
          <p:cNvSpPr txBox="1"/>
          <p:nvPr/>
        </p:nvSpPr>
        <p:spPr>
          <a:xfrm rot="18898324">
            <a:off x="15699507" y="1229667"/>
            <a:ext cx="6669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1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68F170D8-46B0-A947-B89E-390E9020AD5A}"/>
              </a:ext>
            </a:extLst>
          </p:cNvPr>
          <p:cNvSpPr txBox="1"/>
          <p:nvPr/>
        </p:nvSpPr>
        <p:spPr>
          <a:xfrm rot="18898324">
            <a:off x="15953156" y="1228683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2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713185B-3228-6A41-840B-562663402297}"/>
              </a:ext>
            </a:extLst>
          </p:cNvPr>
          <p:cNvSpPr txBox="1"/>
          <p:nvPr/>
        </p:nvSpPr>
        <p:spPr>
          <a:xfrm rot="18898324">
            <a:off x="16239130" y="1228681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bar13</a:t>
            </a:r>
          </a:p>
        </p:txBody>
      </p:sp>
      <p:pic>
        <p:nvPicPr>
          <p:cNvPr id="58" name="图片 57">
            <a:extLst>
              <a:ext uri="{FF2B5EF4-FFF2-40B4-BE49-F238E27FC236}">
                <a16:creationId xmlns:a16="http://schemas.microsoft.com/office/drawing/2014/main" id="{48B4496E-2D52-1C45-BF04-9A691668F7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42992" y="1602844"/>
            <a:ext cx="535204" cy="4518604"/>
          </a:xfrm>
          <a:prstGeom prst="rect">
            <a:avLst/>
          </a:prstGeom>
        </p:spPr>
      </p:pic>
      <p:sp>
        <p:nvSpPr>
          <p:cNvPr id="59" name="文本框 58">
            <a:extLst>
              <a:ext uri="{FF2B5EF4-FFF2-40B4-BE49-F238E27FC236}">
                <a16:creationId xmlns:a16="http://schemas.microsoft.com/office/drawing/2014/main" id="{28D08DAC-72C1-D442-B2E1-666D4A011732}"/>
              </a:ext>
            </a:extLst>
          </p:cNvPr>
          <p:cNvSpPr txBox="1"/>
          <p:nvPr/>
        </p:nvSpPr>
        <p:spPr>
          <a:xfrm>
            <a:off x="10814583" y="160825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4DF2D294-18FA-B342-9C1C-47426D6F901D}"/>
              </a:ext>
            </a:extLst>
          </p:cNvPr>
          <p:cNvSpPr txBox="1"/>
          <p:nvPr/>
        </p:nvSpPr>
        <p:spPr>
          <a:xfrm>
            <a:off x="10810945" y="195488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2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49C40F38-D3DC-4B44-848C-681D1F07AFEA}"/>
              </a:ext>
            </a:extLst>
          </p:cNvPr>
          <p:cNvSpPr txBox="1"/>
          <p:nvPr/>
        </p:nvSpPr>
        <p:spPr>
          <a:xfrm>
            <a:off x="10810945" y="240199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3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2F5C473E-D53E-D74A-8576-981DB3CF763A}"/>
              </a:ext>
            </a:extLst>
          </p:cNvPr>
          <p:cNvSpPr txBox="1"/>
          <p:nvPr/>
        </p:nvSpPr>
        <p:spPr>
          <a:xfrm>
            <a:off x="10810945" y="276953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4</a:t>
            </a: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1082E020-AD99-E84D-865A-AB1B1BB54304}"/>
              </a:ext>
            </a:extLst>
          </p:cNvPr>
          <p:cNvSpPr txBox="1"/>
          <p:nvPr/>
        </p:nvSpPr>
        <p:spPr>
          <a:xfrm>
            <a:off x="10810945" y="307385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5</a:t>
            </a: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1B05FE9-3875-624A-88D9-6F8DB4CFE1A1}"/>
              </a:ext>
            </a:extLst>
          </p:cNvPr>
          <p:cNvSpPr txBox="1"/>
          <p:nvPr/>
        </p:nvSpPr>
        <p:spPr>
          <a:xfrm>
            <a:off x="10810945" y="348304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6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915697FE-7E9B-684E-B5B3-4BF9A546337C}"/>
              </a:ext>
            </a:extLst>
          </p:cNvPr>
          <p:cNvSpPr txBox="1"/>
          <p:nvPr/>
        </p:nvSpPr>
        <p:spPr>
          <a:xfrm>
            <a:off x="10810945" y="386684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7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67C30DE9-336C-FD4E-BD74-A92EEB4794DE}"/>
              </a:ext>
            </a:extLst>
          </p:cNvPr>
          <p:cNvSpPr txBox="1"/>
          <p:nvPr/>
        </p:nvSpPr>
        <p:spPr>
          <a:xfrm>
            <a:off x="10810945" y="418762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8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CF442E9E-AC74-8D4A-877D-9EC5935BF0F3}"/>
              </a:ext>
            </a:extLst>
          </p:cNvPr>
          <p:cNvSpPr txBox="1"/>
          <p:nvPr/>
        </p:nvSpPr>
        <p:spPr>
          <a:xfrm>
            <a:off x="10810945" y="451922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9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E862C72C-22DD-0143-8D62-10A7E5275127}"/>
              </a:ext>
            </a:extLst>
          </p:cNvPr>
          <p:cNvSpPr txBox="1"/>
          <p:nvPr/>
        </p:nvSpPr>
        <p:spPr>
          <a:xfrm>
            <a:off x="10810945" y="479934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0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DF5989D4-04BE-9A48-BE05-6F3C718F6D7E}"/>
              </a:ext>
            </a:extLst>
          </p:cNvPr>
          <p:cNvSpPr txBox="1"/>
          <p:nvPr/>
        </p:nvSpPr>
        <p:spPr>
          <a:xfrm>
            <a:off x="10810945" y="5102334"/>
            <a:ext cx="479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1</a:t>
            </a: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384DE372-B0F9-9C4D-A24C-923B3EF42121}"/>
              </a:ext>
            </a:extLst>
          </p:cNvPr>
          <p:cNvSpPr txBox="1"/>
          <p:nvPr/>
        </p:nvSpPr>
        <p:spPr>
          <a:xfrm>
            <a:off x="10810945" y="5328981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2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60D1F3CB-C515-BA47-A7B0-2928FC55F1BE}"/>
              </a:ext>
            </a:extLst>
          </p:cNvPr>
          <p:cNvSpPr txBox="1"/>
          <p:nvPr/>
        </p:nvSpPr>
        <p:spPr>
          <a:xfrm>
            <a:off x="10810945" y="5489822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3</a:t>
            </a: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E06318CA-B8B3-CF4C-973B-E41746CF371D}"/>
              </a:ext>
            </a:extLst>
          </p:cNvPr>
          <p:cNvSpPr txBox="1"/>
          <p:nvPr/>
        </p:nvSpPr>
        <p:spPr>
          <a:xfrm>
            <a:off x="10815428" y="561532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4</a:t>
            </a: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F06ADC1F-75C8-D140-AE73-569DAEBDF44F}"/>
              </a:ext>
            </a:extLst>
          </p:cNvPr>
          <p:cNvSpPr txBox="1"/>
          <p:nvPr/>
        </p:nvSpPr>
        <p:spPr>
          <a:xfrm>
            <a:off x="10814583" y="576317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5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BE9EBC5E-9BE8-6D45-88A8-68D1E8396044}"/>
              </a:ext>
            </a:extLst>
          </p:cNvPr>
          <p:cNvSpPr txBox="1"/>
          <p:nvPr/>
        </p:nvSpPr>
        <p:spPr>
          <a:xfrm>
            <a:off x="10814583" y="589757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6</a:t>
            </a:r>
          </a:p>
        </p:txBody>
      </p:sp>
      <p:pic>
        <p:nvPicPr>
          <p:cNvPr id="75" name="图片 74">
            <a:extLst>
              <a:ext uri="{FF2B5EF4-FFF2-40B4-BE49-F238E27FC236}">
                <a16:creationId xmlns:a16="http://schemas.microsoft.com/office/drawing/2014/main" id="{99A9A0B7-5481-3F42-AF12-E49EA004B3B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520332" y="1565960"/>
            <a:ext cx="535204" cy="4518604"/>
          </a:xfrm>
          <a:prstGeom prst="rect">
            <a:avLst/>
          </a:prstGeom>
        </p:spPr>
      </p:pic>
      <p:sp>
        <p:nvSpPr>
          <p:cNvPr id="76" name="文本框 75">
            <a:extLst>
              <a:ext uri="{FF2B5EF4-FFF2-40B4-BE49-F238E27FC236}">
                <a16:creationId xmlns:a16="http://schemas.microsoft.com/office/drawing/2014/main" id="{ADC43A11-4C8A-E548-8967-903428439408}"/>
              </a:ext>
            </a:extLst>
          </p:cNvPr>
          <p:cNvSpPr txBox="1"/>
          <p:nvPr/>
        </p:nvSpPr>
        <p:spPr>
          <a:xfrm>
            <a:off x="16491923" y="159826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28645C81-768C-1B4B-A092-4010C7DFD7E1}"/>
              </a:ext>
            </a:extLst>
          </p:cNvPr>
          <p:cNvSpPr txBox="1"/>
          <p:nvPr/>
        </p:nvSpPr>
        <p:spPr>
          <a:xfrm>
            <a:off x="16488285" y="194489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2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DF821AED-1A01-2049-A753-C43468424285}"/>
              </a:ext>
            </a:extLst>
          </p:cNvPr>
          <p:cNvSpPr txBox="1"/>
          <p:nvPr/>
        </p:nvSpPr>
        <p:spPr>
          <a:xfrm>
            <a:off x="16488285" y="239200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3</a:t>
            </a: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1BC22C38-CD11-E249-A684-D6F2A30300A0}"/>
              </a:ext>
            </a:extLst>
          </p:cNvPr>
          <p:cNvSpPr txBox="1"/>
          <p:nvPr/>
        </p:nvSpPr>
        <p:spPr>
          <a:xfrm>
            <a:off x="16488285" y="275954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4</a:t>
            </a: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AD1FD109-631C-5C4D-A005-7FAB994EDE7E}"/>
              </a:ext>
            </a:extLst>
          </p:cNvPr>
          <p:cNvSpPr txBox="1"/>
          <p:nvPr/>
        </p:nvSpPr>
        <p:spPr>
          <a:xfrm>
            <a:off x="16488285" y="306386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5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6531DAE7-4390-E84E-8C82-B70FDBA30402}"/>
              </a:ext>
            </a:extLst>
          </p:cNvPr>
          <p:cNvSpPr txBox="1"/>
          <p:nvPr/>
        </p:nvSpPr>
        <p:spPr>
          <a:xfrm>
            <a:off x="16488285" y="347305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6</a:t>
            </a: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E812434D-B02B-D74B-8DFA-08F74002B03A}"/>
              </a:ext>
            </a:extLst>
          </p:cNvPr>
          <p:cNvSpPr txBox="1"/>
          <p:nvPr/>
        </p:nvSpPr>
        <p:spPr>
          <a:xfrm>
            <a:off x="16488285" y="385685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7</a:t>
            </a: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2DC04D02-23FE-8142-9490-A92DEF71A067}"/>
              </a:ext>
            </a:extLst>
          </p:cNvPr>
          <p:cNvSpPr txBox="1"/>
          <p:nvPr/>
        </p:nvSpPr>
        <p:spPr>
          <a:xfrm>
            <a:off x="16488285" y="417763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8</a:t>
            </a: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4ECD3443-E202-8248-97A4-B4A79CE9A86D}"/>
              </a:ext>
            </a:extLst>
          </p:cNvPr>
          <p:cNvSpPr txBox="1"/>
          <p:nvPr/>
        </p:nvSpPr>
        <p:spPr>
          <a:xfrm>
            <a:off x="16488285" y="450923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9</a:t>
            </a: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68667399-D63C-304D-8A0F-90E4FEDC95EC}"/>
              </a:ext>
            </a:extLst>
          </p:cNvPr>
          <p:cNvSpPr txBox="1"/>
          <p:nvPr/>
        </p:nvSpPr>
        <p:spPr>
          <a:xfrm>
            <a:off x="16488285" y="478935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0</a:t>
            </a: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5A358B35-1C84-9C49-812B-B6CCEA5C81F0}"/>
              </a:ext>
            </a:extLst>
          </p:cNvPr>
          <p:cNvSpPr txBox="1"/>
          <p:nvPr/>
        </p:nvSpPr>
        <p:spPr>
          <a:xfrm>
            <a:off x="16488285" y="5092344"/>
            <a:ext cx="4794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1</a:t>
            </a: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B4714842-E62D-E845-8626-56EA4F68E845}"/>
              </a:ext>
            </a:extLst>
          </p:cNvPr>
          <p:cNvSpPr txBox="1"/>
          <p:nvPr/>
        </p:nvSpPr>
        <p:spPr>
          <a:xfrm>
            <a:off x="16488285" y="5318991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2</a:t>
            </a: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A3F54B95-F6EB-B947-B8F3-3230843B639A}"/>
              </a:ext>
            </a:extLst>
          </p:cNvPr>
          <p:cNvSpPr txBox="1"/>
          <p:nvPr/>
        </p:nvSpPr>
        <p:spPr>
          <a:xfrm>
            <a:off x="16488285" y="5479832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3</a:t>
            </a: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6833CDE4-934D-A046-BDCE-A423AFE2402F}"/>
              </a:ext>
            </a:extLst>
          </p:cNvPr>
          <p:cNvSpPr txBox="1"/>
          <p:nvPr/>
        </p:nvSpPr>
        <p:spPr>
          <a:xfrm>
            <a:off x="16492768" y="5605338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4</a:t>
            </a: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72611205-723F-FF4B-92A3-1E187F9F4ABC}"/>
              </a:ext>
            </a:extLst>
          </p:cNvPr>
          <p:cNvSpPr txBox="1"/>
          <p:nvPr/>
        </p:nvSpPr>
        <p:spPr>
          <a:xfrm>
            <a:off x="16491923" y="575318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5</a:t>
            </a: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B00BC770-DFE0-E645-A481-E6478284E1EE}"/>
              </a:ext>
            </a:extLst>
          </p:cNvPr>
          <p:cNvSpPr txBox="1"/>
          <p:nvPr/>
        </p:nvSpPr>
        <p:spPr>
          <a:xfrm>
            <a:off x="16491923" y="5887585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16</a:t>
            </a:r>
          </a:p>
        </p:txBody>
      </p:sp>
    </p:spTree>
    <p:extLst>
      <p:ext uri="{BB962C8B-B14F-4D97-AF65-F5344CB8AC3E}">
        <p14:creationId xmlns:p14="http://schemas.microsoft.com/office/powerpoint/2010/main" val="697656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03</Words>
  <Application>Microsoft Macintosh PowerPoint</Application>
  <PresentationFormat>自定义</PresentationFormat>
  <Paragraphs>7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chao Xu</dc:creator>
  <cp:lastModifiedBy>Zhichao Xu</cp:lastModifiedBy>
  <cp:revision>3</cp:revision>
  <dcterms:created xsi:type="dcterms:W3CDTF">2020-02-20T13:04:25Z</dcterms:created>
  <dcterms:modified xsi:type="dcterms:W3CDTF">2020-06-12T15:35:28Z</dcterms:modified>
</cp:coreProperties>
</file>